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1" r:id="rId2"/>
    <p:sldId id="311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DE2755DE-2DB5-4FDC-AE3A-A328ACFA07EA}">
          <p14:sldIdLst/>
        </p14:section>
        <p14:section name="Untitled Section" id="{D12D3FE3-7EBA-4B1F-AA1B-22596F07AC95}">
          <p14:sldIdLst>
            <p14:sldId id="261"/>
            <p14:sldId id="311"/>
          </p14:sldIdLst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2" d="100"/>
          <a:sy n="62" d="100"/>
        </p:scale>
        <p:origin x="252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13166D-5D68-4F3D-A58A-63DA4BA2C4FB}" type="datetimeFigureOut">
              <a:rPr lang="en-CA" smtClean="0"/>
              <a:t>2024-03-05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FEABD80-BD39-441B-88D3-945EF35EFC6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386384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2C53F8E-63EC-47A9-BEBA-6AE978F27FDE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9296092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2C53F8E-63EC-47A9-BEBA-6AE978F27FDE}" type="slidenum">
              <a:rPr lang="en-CA" smtClean="0"/>
              <a:t>2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818688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D0B3A-A369-456B-BC8C-FC5F141760B8}" type="datetimeFigureOut">
              <a:rPr lang="en-CA" smtClean="0"/>
              <a:t>2024-03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9DC2-12B9-40C7-8AD5-5359AC388D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53806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D0B3A-A369-456B-BC8C-FC5F141760B8}" type="datetimeFigureOut">
              <a:rPr lang="en-CA" smtClean="0"/>
              <a:t>2024-03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9DC2-12B9-40C7-8AD5-5359AC388D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286882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D0B3A-A369-456B-BC8C-FC5F141760B8}" type="datetimeFigureOut">
              <a:rPr lang="en-CA" smtClean="0"/>
              <a:t>2024-03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9DC2-12B9-40C7-8AD5-5359AC388D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428926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D0B3A-A369-456B-BC8C-FC5F141760B8}" type="datetimeFigureOut">
              <a:rPr lang="en-CA" smtClean="0"/>
              <a:t>2024-03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9DC2-12B9-40C7-8AD5-5359AC388D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66562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D0B3A-A369-456B-BC8C-FC5F141760B8}" type="datetimeFigureOut">
              <a:rPr lang="en-CA" smtClean="0"/>
              <a:t>2024-03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9DC2-12B9-40C7-8AD5-5359AC388D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485926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D0B3A-A369-456B-BC8C-FC5F141760B8}" type="datetimeFigureOut">
              <a:rPr lang="en-CA" smtClean="0"/>
              <a:t>2024-03-0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9DC2-12B9-40C7-8AD5-5359AC388D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677018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D0B3A-A369-456B-BC8C-FC5F141760B8}" type="datetimeFigureOut">
              <a:rPr lang="en-CA" smtClean="0"/>
              <a:t>2024-03-0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9DC2-12B9-40C7-8AD5-5359AC388D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70363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D0B3A-A369-456B-BC8C-FC5F141760B8}" type="datetimeFigureOut">
              <a:rPr lang="en-CA" smtClean="0"/>
              <a:t>2024-03-0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9DC2-12B9-40C7-8AD5-5359AC388D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17617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D0B3A-A369-456B-BC8C-FC5F141760B8}" type="datetimeFigureOut">
              <a:rPr lang="en-CA" smtClean="0"/>
              <a:t>2024-03-0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9DC2-12B9-40C7-8AD5-5359AC388D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46567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D0B3A-A369-456B-BC8C-FC5F141760B8}" type="datetimeFigureOut">
              <a:rPr lang="en-CA" smtClean="0"/>
              <a:t>2024-03-0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9DC2-12B9-40C7-8AD5-5359AC388D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80605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D0B3A-A369-456B-BC8C-FC5F141760B8}" type="datetimeFigureOut">
              <a:rPr lang="en-CA" smtClean="0"/>
              <a:t>2024-03-0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19DC2-12B9-40C7-8AD5-5359AC388D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210700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C3D0B3A-A369-456B-BC8C-FC5F141760B8}" type="datetimeFigureOut">
              <a:rPr lang="en-CA" smtClean="0"/>
              <a:t>2024-03-0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4319DC2-12B9-40C7-8AD5-5359AC388DC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456653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svg"/><Relationship Id="rId5" Type="http://schemas.openxmlformats.org/officeDocument/2006/relationships/image" Target="../media/image5.png"/><Relationship Id="rId4" Type="http://schemas.openxmlformats.org/officeDocument/2006/relationships/image" Target="../media/image4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068C743-79C2-710D-985D-A74AB938B242}"/>
              </a:ext>
            </a:extLst>
          </p:cNvPr>
          <p:cNvSpPr txBox="1"/>
          <p:nvPr/>
        </p:nvSpPr>
        <p:spPr>
          <a:xfrm>
            <a:off x="762451" y="4089561"/>
            <a:ext cx="518114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(A)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cterial Two Hybrid assay querying potential Zip interaction with proteins involved in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aeruginosa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lus assembly. 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itching motility assays for PAO1, JBD26 lysogen, JBD26</a:t>
            </a:r>
            <a:r>
              <a:rPr lang="en-CA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∆zip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ysogen, and PAO1 expressing Zip-GFP from a plasmid. Three independent biological replicates are shown.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6997C93-3332-FD91-2920-155FE897A7D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88479" y="1414156"/>
            <a:ext cx="2362200" cy="1168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1F68994-CD6A-14AA-6B19-843FB2FA648A}"/>
              </a:ext>
            </a:extLst>
          </p:cNvPr>
          <p:cNvSpPr txBox="1"/>
          <p:nvPr/>
        </p:nvSpPr>
        <p:spPr>
          <a:xfrm>
            <a:off x="4109408" y="1013341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B9599A5-796D-90AF-C474-6C98BC6F54DF}"/>
              </a:ext>
            </a:extLst>
          </p:cNvPr>
          <p:cNvSpPr txBox="1"/>
          <p:nvPr/>
        </p:nvSpPr>
        <p:spPr>
          <a:xfrm>
            <a:off x="627638" y="1013342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A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98B39DD1-6517-7465-914E-DB43337C20D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7616" y="1083956"/>
            <a:ext cx="3060700" cy="182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52758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068C743-79C2-710D-985D-A74AB938B242}"/>
              </a:ext>
            </a:extLst>
          </p:cNvPr>
          <p:cNvSpPr txBox="1"/>
          <p:nvPr/>
        </p:nvSpPr>
        <p:spPr>
          <a:xfrm>
            <a:off x="617238" y="5849179"/>
            <a:ext cx="592212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(A)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sequences of the predicted promoter regions of the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ip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found in phages JBD26, JBD24, and PA8. (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sequence alignment of Zip homologues found in complete phage genomes. A sequence identity cut-off of 95% was used to remove redundant sequences. 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ip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in phages JBD26 and JBD24 share a common genomic context downstream of the phage tail operon, while PA8 is encoded at the other end of the morphogenetic region, upstream of the small terminase gene. 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E29E1519-3A39-151B-427F-9067B2F32A26}"/>
              </a:ext>
            </a:extLst>
          </p:cNvPr>
          <p:cNvGrpSpPr/>
          <p:nvPr/>
        </p:nvGrpSpPr>
        <p:grpSpPr>
          <a:xfrm>
            <a:off x="74427" y="2136979"/>
            <a:ext cx="6620047" cy="776776"/>
            <a:chOff x="181536" y="700384"/>
            <a:chExt cx="6620047" cy="776776"/>
          </a:xfrm>
        </p:grpSpPr>
        <p:pic>
          <p:nvPicPr>
            <p:cNvPr id="4" name="Graphic 3">
              <a:extLst>
                <a:ext uri="{FF2B5EF4-FFF2-40B4-BE49-F238E27FC236}">
                  <a16:creationId xmlns:a16="http://schemas.microsoft.com/office/drawing/2014/main" id="{AEB255A2-C2A9-50FD-7809-D79BEE2721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rcRect l="11224" b="72105"/>
            <a:stretch/>
          </p:blipFill>
          <p:spPr>
            <a:xfrm>
              <a:off x="1056978" y="700384"/>
              <a:ext cx="5744605" cy="776776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983EB8C1-B969-E3B1-BFAB-390DC6DD6260}"/>
                </a:ext>
              </a:extLst>
            </p:cNvPr>
            <p:cNvSpPr txBox="1"/>
            <p:nvPr/>
          </p:nvSpPr>
          <p:spPr>
            <a:xfrm>
              <a:off x="181536" y="769274"/>
              <a:ext cx="955711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ts val="750"/>
                </a:lnSpc>
              </a:pP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DMS3</a:t>
              </a:r>
            </a:p>
            <a:p>
              <a:pPr algn="r">
                <a:lnSpc>
                  <a:spcPts val="750"/>
                </a:lnSpc>
              </a:pPr>
              <a:r>
                <a:rPr lang="en-CA" sz="700" i="0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vB_Pae_CF183a</a:t>
              </a:r>
            </a:p>
            <a:p>
              <a:pPr algn="r">
                <a:lnSpc>
                  <a:spcPts val="750"/>
                </a:lnSpc>
              </a:pPr>
              <a:r>
                <a:rPr lang="en-CA" sz="700" i="0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vB_PaeS-D14F</a:t>
              </a:r>
            </a:p>
            <a:p>
              <a:pPr algn="r">
                <a:lnSpc>
                  <a:spcPts val="750"/>
                </a:lnSpc>
              </a:pPr>
              <a:r>
                <a:rPr lang="en-CA" sz="700" i="0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vB_PaeS_PM105</a:t>
              </a:r>
            </a:p>
            <a:p>
              <a:pPr algn="r">
                <a:lnSpc>
                  <a:spcPts val="750"/>
                </a:lnSpc>
              </a:pPr>
              <a:r>
                <a:rPr lang="en-CA" sz="700" i="0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vB_Pae-SS2019XII</a:t>
              </a:r>
            </a:p>
            <a:p>
              <a:pPr algn="r">
                <a:lnSpc>
                  <a:spcPts val="750"/>
                </a:lnSpc>
              </a:pPr>
              <a:r>
                <a:rPr lang="en-CA" sz="700" i="0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vB_Pae_CF63a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54D1F5BB-FCAF-3BEB-0DC7-C891D2CF59B3}"/>
              </a:ext>
            </a:extLst>
          </p:cNvPr>
          <p:cNvSpPr txBox="1"/>
          <p:nvPr/>
        </p:nvSpPr>
        <p:spPr>
          <a:xfrm>
            <a:off x="242052" y="507953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9CD9DAA-0F44-009E-0F9C-195BA6C2A241}"/>
              </a:ext>
            </a:extLst>
          </p:cNvPr>
          <p:cNvSpPr txBox="1"/>
          <p:nvPr/>
        </p:nvSpPr>
        <p:spPr>
          <a:xfrm>
            <a:off x="245899" y="1890758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9" name="Graphic 28">
            <a:extLst>
              <a:ext uri="{FF2B5EF4-FFF2-40B4-BE49-F238E27FC236}">
                <a16:creationId xmlns:a16="http://schemas.microsoft.com/office/drawing/2014/main" id="{886990D1-FFEC-A8C9-541F-737775665B7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rcRect t="-1" b="36650"/>
          <a:stretch/>
        </p:blipFill>
        <p:spPr>
          <a:xfrm>
            <a:off x="617238" y="754174"/>
            <a:ext cx="5744605" cy="971259"/>
          </a:xfrm>
          <a:prstGeom prst="rect">
            <a:avLst/>
          </a:prstGeom>
        </p:spPr>
      </p:pic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FE2123BB-5E38-EFEA-4BD6-CA43B4823081}"/>
              </a:ext>
            </a:extLst>
          </p:cNvPr>
          <p:cNvCxnSpPr>
            <a:cxnSpLocks/>
          </p:cNvCxnSpPr>
          <p:nvPr/>
        </p:nvCxnSpPr>
        <p:spPr>
          <a:xfrm>
            <a:off x="1316352" y="4134166"/>
            <a:ext cx="1412611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" name="Group 8">
            <a:extLst>
              <a:ext uri="{FF2B5EF4-FFF2-40B4-BE49-F238E27FC236}">
                <a16:creationId xmlns:a16="http://schemas.microsoft.com/office/drawing/2014/main" id="{3F032E27-9868-4F67-B7B4-44CEAA1F79C0}"/>
              </a:ext>
            </a:extLst>
          </p:cNvPr>
          <p:cNvGrpSpPr/>
          <p:nvPr/>
        </p:nvGrpSpPr>
        <p:grpSpPr>
          <a:xfrm>
            <a:off x="908080" y="3462761"/>
            <a:ext cx="1903409" cy="1037976"/>
            <a:chOff x="4462808" y="615719"/>
            <a:chExt cx="1903409" cy="1037976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01A58C23-B5F6-0DAF-D126-8B24BD858B39}"/>
                </a:ext>
              </a:extLst>
            </p:cNvPr>
            <p:cNvGrpSpPr/>
            <p:nvPr/>
          </p:nvGrpSpPr>
          <p:grpSpPr>
            <a:xfrm>
              <a:off x="4877430" y="913432"/>
              <a:ext cx="1488787" cy="740263"/>
              <a:chOff x="1379523" y="2465586"/>
              <a:chExt cx="1488787" cy="740263"/>
            </a:xfrm>
          </p:grpSpPr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4C447CC5-7909-7468-D75B-23F6DFA2A9C5}"/>
                  </a:ext>
                </a:extLst>
              </p:cNvPr>
              <p:cNvGrpSpPr/>
              <p:nvPr/>
            </p:nvGrpSpPr>
            <p:grpSpPr>
              <a:xfrm>
                <a:off x="1379523" y="2465586"/>
                <a:ext cx="1412611" cy="228600"/>
                <a:chOff x="1344522" y="2828295"/>
                <a:chExt cx="1412611" cy="228600"/>
              </a:xfrm>
            </p:grpSpPr>
            <p:grpSp>
              <p:nvGrpSpPr>
                <p:cNvPr id="32" name="Group 31">
                  <a:extLst>
                    <a:ext uri="{FF2B5EF4-FFF2-40B4-BE49-F238E27FC236}">
                      <a16:creationId xmlns:a16="http://schemas.microsoft.com/office/drawing/2014/main" id="{0F053FFF-8A90-D359-2086-3326DA8BDF60}"/>
                    </a:ext>
                  </a:extLst>
                </p:cNvPr>
                <p:cNvGrpSpPr/>
                <p:nvPr/>
              </p:nvGrpSpPr>
              <p:grpSpPr>
                <a:xfrm>
                  <a:off x="1344522" y="2828295"/>
                  <a:ext cx="1412611" cy="228600"/>
                  <a:chOff x="1342305" y="2964691"/>
                  <a:chExt cx="1412611" cy="228600"/>
                </a:xfrm>
              </p:grpSpPr>
              <p:cxnSp>
                <p:nvCxnSpPr>
                  <p:cNvPr id="35" name="Straight Connector 34">
                    <a:extLst>
                      <a:ext uri="{FF2B5EF4-FFF2-40B4-BE49-F238E27FC236}">
                        <a16:creationId xmlns:a16="http://schemas.microsoft.com/office/drawing/2014/main" id="{E1063028-71E3-1B78-F334-0BB60676B10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342305" y="3078033"/>
                    <a:ext cx="1412611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6" name="Arrow: Right 26">
                    <a:extLst>
                      <a:ext uri="{FF2B5EF4-FFF2-40B4-BE49-F238E27FC236}">
                        <a16:creationId xmlns:a16="http://schemas.microsoft.com/office/drawing/2014/main" id="{FAECE8E7-899E-201B-A702-84DD4ED54597}"/>
                      </a:ext>
                    </a:extLst>
                  </p:cNvPr>
                  <p:cNvSpPr/>
                  <p:nvPr/>
                </p:nvSpPr>
                <p:spPr>
                  <a:xfrm>
                    <a:off x="1342305" y="2975619"/>
                    <a:ext cx="618195" cy="200055"/>
                  </a:xfrm>
                  <a:prstGeom prst="rightArrow">
                    <a:avLst/>
                  </a:prstGeom>
                  <a:solidFill>
                    <a:schemeClr val="bg2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dirty="0"/>
                  </a:p>
                </p:txBody>
              </p:sp>
              <p:sp>
                <p:nvSpPr>
                  <p:cNvPr id="37" name="Arrow: Right 27">
                    <a:extLst>
                      <a:ext uri="{FF2B5EF4-FFF2-40B4-BE49-F238E27FC236}">
                        <a16:creationId xmlns:a16="http://schemas.microsoft.com/office/drawing/2014/main" id="{431F47AC-6287-8835-E130-EE356E94DD8C}"/>
                      </a:ext>
                    </a:extLst>
                  </p:cNvPr>
                  <p:cNvSpPr/>
                  <p:nvPr/>
                </p:nvSpPr>
                <p:spPr>
                  <a:xfrm>
                    <a:off x="2399069" y="2964691"/>
                    <a:ext cx="305762" cy="228600"/>
                  </a:xfrm>
                  <a:prstGeom prst="rightArrow">
                    <a:avLst/>
                  </a:prstGeom>
                  <a:solidFill>
                    <a:srgbClr val="33CCFF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" name="Arrow: Right 43">
                    <a:extLst>
                      <a:ext uri="{FF2B5EF4-FFF2-40B4-BE49-F238E27FC236}">
                        <a16:creationId xmlns:a16="http://schemas.microsoft.com/office/drawing/2014/main" id="{0AD51CA4-A7DA-1CA6-8B7A-9EE3574A3513}"/>
                      </a:ext>
                    </a:extLst>
                  </p:cNvPr>
                  <p:cNvSpPr/>
                  <p:nvPr/>
                </p:nvSpPr>
                <p:spPr>
                  <a:xfrm>
                    <a:off x="1972383" y="2974411"/>
                    <a:ext cx="320952" cy="200055"/>
                  </a:xfrm>
                  <a:prstGeom prst="rightArrow">
                    <a:avLst/>
                  </a:prstGeom>
                  <a:solidFill>
                    <a:schemeClr val="bg2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/>
                  </a:p>
                </p:txBody>
              </p:sp>
            </p:grp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9D64C4C8-2591-BE8C-B2DD-D6B8034146C1}"/>
                    </a:ext>
                  </a:extLst>
                </p:cNvPr>
                <p:cNvSpPr txBox="1"/>
                <p:nvPr/>
              </p:nvSpPr>
              <p:spPr>
                <a:xfrm>
                  <a:off x="2386743" y="2852081"/>
                  <a:ext cx="28405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ip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3C797278-8CA5-D631-B189-C11640F91169}"/>
                    </a:ext>
                  </a:extLst>
                </p:cNvPr>
                <p:cNvSpPr txBox="1"/>
                <p:nvPr/>
              </p:nvSpPr>
              <p:spPr>
                <a:xfrm>
                  <a:off x="1403351" y="2845342"/>
                  <a:ext cx="48122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ail </a:t>
                  </a:r>
                  <a:r>
                    <a:rPr lang="en-US" sz="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ibre</a:t>
                  </a:r>
                  <a:endParaRPr 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3D174F41-61A8-5156-9B66-D70512554BD8}"/>
                  </a:ext>
                </a:extLst>
              </p:cNvPr>
              <p:cNvGrpSpPr/>
              <p:nvPr/>
            </p:nvGrpSpPr>
            <p:grpSpPr>
              <a:xfrm>
                <a:off x="1379523" y="2728489"/>
                <a:ext cx="1362526" cy="228600"/>
                <a:chOff x="1344522" y="2828295"/>
                <a:chExt cx="1362526" cy="228600"/>
              </a:xfrm>
            </p:grpSpPr>
            <p:grpSp>
              <p:nvGrpSpPr>
                <p:cNvPr id="25" name="Group 24">
                  <a:extLst>
                    <a:ext uri="{FF2B5EF4-FFF2-40B4-BE49-F238E27FC236}">
                      <a16:creationId xmlns:a16="http://schemas.microsoft.com/office/drawing/2014/main" id="{14D57EDF-7137-5F87-C284-F6962DA4172A}"/>
                    </a:ext>
                  </a:extLst>
                </p:cNvPr>
                <p:cNvGrpSpPr/>
                <p:nvPr/>
              </p:nvGrpSpPr>
              <p:grpSpPr>
                <a:xfrm>
                  <a:off x="1344522" y="2828295"/>
                  <a:ext cx="1362526" cy="228600"/>
                  <a:chOff x="1342305" y="2964691"/>
                  <a:chExt cx="1362526" cy="228600"/>
                </a:xfrm>
              </p:grpSpPr>
              <p:sp>
                <p:nvSpPr>
                  <p:cNvPr id="28" name="Arrow: Right 26">
                    <a:extLst>
                      <a:ext uri="{FF2B5EF4-FFF2-40B4-BE49-F238E27FC236}">
                        <a16:creationId xmlns:a16="http://schemas.microsoft.com/office/drawing/2014/main" id="{DCF7E175-866B-F758-A7C0-111427AFC900}"/>
                      </a:ext>
                    </a:extLst>
                  </p:cNvPr>
                  <p:cNvSpPr/>
                  <p:nvPr/>
                </p:nvSpPr>
                <p:spPr>
                  <a:xfrm>
                    <a:off x="1342305" y="2975619"/>
                    <a:ext cx="618195" cy="200055"/>
                  </a:xfrm>
                  <a:prstGeom prst="rightArrow">
                    <a:avLst/>
                  </a:prstGeom>
                  <a:solidFill>
                    <a:schemeClr val="bg2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dirty="0"/>
                  </a:p>
                </p:txBody>
              </p:sp>
              <p:sp>
                <p:nvSpPr>
                  <p:cNvPr id="30" name="Arrow: Right 27">
                    <a:extLst>
                      <a:ext uri="{FF2B5EF4-FFF2-40B4-BE49-F238E27FC236}">
                        <a16:creationId xmlns:a16="http://schemas.microsoft.com/office/drawing/2014/main" id="{6B4E6650-9E26-1A41-37C9-E47A6C1D6F08}"/>
                      </a:ext>
                    </a:extLst>
                  </p:cNvPr>
                  <p:cNvSpPr/>
                  <p:nvPr/>
                </p:nvSpPr>
                <p:spPr>
                  <a:xfrm>
                    <a:off x="2399069" y="2964691"/>
                    <a:ext cx="305762" cy="228600"/>
                  </a:xfrm>
                  <a:prstGeom prst="rightArrow">
                    <a:avLst/>
                  </a:prstGeom>
                  <a:solidFill>
                    <a:srgbClr val="76D6FF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" name="Arrow: Right 43">
                    <a:extLst>
                      <a:ext uri="{FF2B5EF4-FFF2-40B4-BE49-F238E27FC236}">
                        <a16:creationId xmlns:a16="http://schemas.microsoft.com/office/drawing/2014/main" id="{DDF278DA-C966-6D94-AAA8-7F0EA573F505}"/>
                      </a:ext>
                    </a:extLst>
                  </p:cNvPr>
                  <p:cNvSpPr/>
                  <p:nvPr/>
                </p:nvSpPr>
                <p:spPr>
                  <a:xfrm>
                    <a:off x="1972383" y="2974411"/>
                    <a:ext cx="320952" cy="200055"/>
                  </a:xfrm>
                  <a:prstGeom prst="rightArrow">
                    <a:avLst/>
                  </a:prstGeom>
                  <a:solidFill>
                    <a:schemeClr val="bg2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/>
                  </a:p>
                </p:txBody>
              </p:sp>
            </p:grp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21354B3B-07C8-CAD6-983E-3E0C5535212E}"/>
                    </a:ext>
                  </a:extLst>
                </p:cNvPr>
                <p:cNvSpPr txBox="1"/>
                <p:nvPr/>
              </p:nvSpPr>
              <p:spPr>
                <a:xfrm>
                  <a:off x="2386743" y="2846025"/>
                  <a:ext cx="28405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ip</a:t>
                  </a: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C4C52CD3-76B1-C4BC-BED1-7742AA17D458}"/>
                    </a:ext>
                  </a:extLst>
                </p:cNvPr>
                <p:cNvSpPr txBox="1"/>
                <p:nvPr/>
              </p:nvSpPr>
              <p:spPr>
                <a:xfrm>
                  <a:off x="1403351" y="2845342"/>
                  <a:ext cx="48122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ail </a:t>
                  </a:r>
                  <a:r>
                    <a:rPr lang="en-US" sz="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ibre</a:t>
                  </a:r>
                  <a:endParaRPr 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DA625114-CE86-846F-8681-CB9BF365C419}"/>
                  </a:ext>
                </a:extLst>
              </p:cNvPr>
              <p:cNvGrpSpPr/>
              <p:nvPr/>
            </p:nvGrpSpPr>
            <p:grpSpPr>
              <a:xfrm>
                <a:off x="1379523" y="2977249"/>
                <a:ext cx="1488787" cy="228600"/>
                <a:chOff x="1417841" y="3563265"/>
                <a:chExt cx="1488787" cy="228600"/>
              </a:xfrm>
            </p:grpSpPr>
            <p:cxnSp>
              <p:nvCxnSpPr>
                <p:cNvPr id="18" name="Straight Connector 17">
                  <a:extLst>
                    <a:ext uri="{FF2B5EF4-FFF2-40B4-BE49-F238E27FC236}">
                      <a16:creationId xmlns:a16="http://schemas.microsoft.com/office/drawing/2014/main" id="{EF549411-016C-7D23-329C-88DB6C21A49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20378" y="3677565"/>
                  <a:ext cx="1332000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" name="Arrow: Right 43">
                  <a:extLst>
                    <a:ext uri="{FF2B5EF4-FFF2-40B4-BE49-F238E27FC236}">
                      <a16:creationId xmlns:a16="http://schemas.microsoft.com/office/drawing/2014/main" id="{01C0DE44-2931-206B-05BF-FFD088AFC585}"/>
                    </a:ext>
                  </a:extLst>
                </p:cNvPr>
                <p:cNvSpPr/>
                <p:nvPr/>
              </p:nvSpPr>
              <p:spPr>
                <a:xfrm>
                  <a:off x="1417841" y="3580954"/>
                  <a:ext cx="320952" cy="200055"/>
                </a:xfrm>
                <a:prstGeom prst="rightArrow">
                  <a:avLst/>
                </a:prstGeom>
                <a:solidFill>
                  <a:schemeClr val="bg2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/>
                </a:p>
              </p:txBody>
            </p:sp>
            <p:grpSp>
              <p:nvGrpSpPr>
                <p:cNvPr id="20" name="Group 19">
                  <a:extLst>
                    <a:ext uri="{FF2B5EF4-FFF2-40B4-BE49-F238E27FC236}">
                      <a16:creationId xmlns:a16="http://schemas.microsoft.com/office/drawing/2014/main" id="{823E126D-3B9B-2430-B98F-EA61B5D8D810}"/>
                    </a:ext>
                  </a:extLst>
                </p:cNvPr>
                <p:cNvGrpSpPr/>
                <p:nvPr/>
              </p:nvGrpSpPr>
              <p:grpSpPr>
                <a:xfrm>
                  <a:off x="1801377" y="3563265"/>
                  <a:ext cx="317641" cy="228600"/>
                  <a:chOff x="2460312" y="3835276"/>
                  <a:chExt cx="317641" cy="228600"/>
                </a:xfrm>
              </p:grpSpPr>
              <p:sp>
                <p:nvSpPr>
                  <p:cNvPr id="23" name="Arrow: Right 27">
                    <a:extLst>
                      <a:ext uri="{FF2B5EF4-FFF2-40B4-BE49-F238E27FC236}">
                        <a16:creationId xmlns:a16="http://schemas.microsoft.com/office/drawing/2014/main" id="{1FF5C3EC-9DD0-C380-DF66-683815031422}"/>
                      </a:ext>
                    </a:extLst>
                  </p:cNvPr>
                  <p:cNvSpPr/>
                  <p:nvPr/>
                </p:nvSpPr>
                <p:spPr>
                  <a:xfrm flipH="1">
                    <a:off x="2460312" y="3835276"/>
                    <a:ext cx="305762" cy="228600"/>
                  </a:xfrm>
                  <a:prstGeom prst="rightArrow">
                    <a:avLst/>
                  </a:prstGeom>
                  <a:solidFill>
                    <a:srgbClr val="0099FF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" name="TextBox 23">
                    <a:extLst>
                      <a:ext uri="{FF2B5EF4-FFF2-40B4-BE49-F238E27FC236}">
                        <a16:creationId xmlns:a16="http://schemas.microsoft.com/office/drawing/2014/main" id="{9795867B-C7C5-97BE-D5D0-29A7D0FFD71D}"/>
                      </a:ext>
                    </a:extLst>
                  </p:cNvPr>
                  <p:cNvSpPr txBox="1"/>
                  <p:nvPr/>
                </p:nvSpPr>
                <p:spPr>
                  <a:xfrm>
                    <a:off x="2493901" y="3854038"/>
                    <a:ext cx="284052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ip</a:t>
                    </a:r>
                  </a:p>
                </p:txBody>
              </p:sp>
            </p:grpSp>
            <p:sp>
              <p:nvSpPr>
                <p:cNvPr id="21" name="Arrow: Right 26">
                  <a:extLst>
                    <a:ext uri="{FF2B5EF4-FFF2-40B4-BE49-F238E27FC236}">
                      <a16:creationId xmlns:a16="http://schemas.microsoft.com/office/drawing/2014/main" id="{B77DDC2A-061F-CC77-04A5-94D2E18B0199}"/>
                    </a:ext>
                  </a:extLst>
                </p:cNvPr>
                <p:cNvSpPr/>
                <p:nvPr/>
              </p:nvSpPr>
              <p:spPr>
                <a:xfrm>
                  <a:off x="2243497" y="3567920"/>
                  <a:ext cx="586955" cy="223200"/>
                </a:xfrm>
                <a:prstGeom prst="rightArrow">
                  <a:avLst/>
                </a:prstGeom>
                <a:solidFill>
                  <a:schemeClr val="bg2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dirty="0"/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6F0279B3-9225-621A-5E3B-AC1C558D37D6}"/>
                    </a:ext>
                  </a:extLst>
                </p:cNvPr>
                <p:cNvSpPr txBox="1"/>
                <p:nvPr/>
              </p:nvSpPr>
              <p:spPr>
                <a:xfrm flipH="1">
                  <a:off x="2167323" y="3585189"/>
                  <a:ext cx="739305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mall terminase</a:t>
                  </a:r>
                </a:p>
              </p:txBody>
            </p:sp>
          </p:grpSp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E8452AD-214E-6955-11BB-78A93814388F}"/>
                </a:ext>
              </a:extLst>
            </p:cNvPr>
            <p:cNvSpPr txBox="1"/>
            <p:nvPr/>
          </p:nvSpPr>
          <p:spPr>
            <a:xfrm>
              <a:off x="4462808" y="931554"/>
              <a:ext cx="45236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JBD26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570EBB4-716B-7582-9404-B5CF25367C2D}"/>
                </a:ext>
              </a:extLst>
            </p:cNvPr>
            <p:cNvSpPr txBox="1"/>
            <p:nvPr/>
          </p:nvSpPr>
          <p:spPr>
            <a:xfrm>
              <a:off x="4468775" y="1196465"/>
              <a:ext cx="45236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JBD24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869CED8-C1C0-DB25-F9C4-BA59E2C74B85}"/>
                </a:ext>
              </a:extLst>
            </p:cNvPr>
            <p:cNvSpPr txBox="1"/>
            <p:nvPr/>
          </p:nvSpPr>
          <p:spPr>
            <a:xfrm>
              <a:off x="4561017" y="1449872"/>
              <a:ext cx="35298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PA8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02ED208-FED2-A2AE-5346-996B7B48DAFA}"/>
                </a:ext>
              </a:extLst>
            </p:cNvPr>
            <p:cNvSpPr txBox="1"/>
            <p:nvPr/>
          </p:nvSpPr>
          <p:spPr>
            <a:xfrm>
              <a:off x="4492090" y="615719"/>
              <a:ext cx="2696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Helvetica" pitchFamily="2" charset="0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97534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96</Words>
  <Application>Microsoft Office PowerPoint</Application>
  <PresentationFormat>On-screen Show (4:3)</PresentationFormat>
  <Paragraphs>24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ptos</vt:lpstr>
      <vt:lpstr>Aptos Display</vt:lpstr>
      <vt:lpstr>Arial</vt:lpstr>
      <vt:lpstr>Helvetica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ronique Taylor</dc:creator>
  <cp:lastModifiedBy>Veronique Taylor</cp:lastModifiedBy>
  <cp:revision>1</cp:revision>
  <dcterms:created xsi:type="dcterms:W3CDTF">2024-03-05T17:57:17Z</dcterms:created>
  <dcterms:modified xsi:type="dcterms:W3CDTF">2024-03-05T17:58:08Z</dcterms:modified>
</cp:coreProperties>
</file>